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1D82FB-1E03-4097-9F9A-CAD5E507EB2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79A06A-9EEE-4A1C-949F-1CD85E55C4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938D8E-A518-44D7-B741-4C2A3B9AE47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2BFF98-D634-4A4A-BEEB-144AE37678F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2238F5-0152-4023-9805-19E930EBF9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531CFD-F28B-4F41-A7E1-E40698EFE7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2BFA12-9BFB-4504-A19B-E2C87B8474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B4A8A5-1242-4378-9B84-C7557D7EFC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617CA0-8F18-41EF-85B5-DC4BE8C6AA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0CBCD6-36C9-4C1E-AF5D-91D5BCB63A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004A58-69AF-40DF-B3B9-A0D768DDC9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5C95C1-33FF-4582-8914-8055ABDEA6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46F5F6-8EBE-4EA6-A949-BCC203036B0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http://www.ncbi.nlm.nih.gov/" TargetMode="External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矩形 3"/>
          <p:cNvSpPr/>
          <p:nvPr/>
        </p:nvSpPr>
        <p:spPr>
          <a:xfrm>
            <a:off x="225360" y="388800"/>
            <a:ext cx="637056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Table S3. Gene-specific primers of additional </a:t>
            </a:r>
            <a:r>
              <a:rPr b="1" i="1" lang="en-US" sz="1800" spc="-1" strike="noStrike">
                <a:solidFill>
                  <a:srgbClr val="000000"/>
                </a:solidFill>
                <a:latin typeface="Times New Roman"/>
              </a:rPr>
              <a:t>AS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, </a:t>
            </a:r>
            <a:r>
              <a:rPr b="1" i="1" lang="en-US" sz="1800" spc="-1" strike="noStrike">
                <a:solidFill>
                  <a:srgbClr val="000000"/>
                </a:solidFill>
                <a:latin typeface="Times New Roman"/>
              </a:rPr>
              <a:t>IGPS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, </a:t>
            </a:r>
            <a:r>
              <a:rPr b="1" i="1" lang="en-US" sz="1800" spc="-1" strike="noStrike">
                <a:solidFill>
                  <a:srgbClr val="000000"/>
                </a:solidFill>
                <a:latin typeface="Times New Roman"/>
              </a:rPr>
              <a:t>TS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 and </a:t>
            </a:r>
            <a:r>
              <a:rPr b="1" i="1" lang="en-US" sz="1800" spc="-1" strike="noStrike">
                <a:solidFill>
                  <a:srgbClr val="000000"/>
                </a:solidFill>
                <a:latin typeface="Times New Roman"/>
              </a:rPr>
              <a:t>TDC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 genes used for the real-time PC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784080" y="2062080"/>
          <a:ext cx="5254920" cy="2284560"/>
        </p:xfrm>
        <a:graphic>
          <a:graphicData uri="http://schemas.openxmlformats.org/drawingml/2006/table">
            <a:tbl>
              <a:tblPr/>
              <a:tblGrid>
                <a:gridCol w="592200"/>
                <a:gridCol w="903240"/>
                <a:gridCol w="2006640"/>
                <a:gridCol w="1752840"/>
              </a:tblGrid>
              <a:tr h="2062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en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 baseline="30000">
                          <a:solidFill>
                            <a:srgbClr val="000000"/>
                          </a:solidFill>
                          <a:latin typeface="Times New Roman"/>
                        </a:rPr>
                        <a:t>a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ccess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orward primer (5’-3’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everse primer (5’-3’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4480">
                <a:tc rowSpan="3"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03g08265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TGCATTGCGTATTGTCAATCCT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TTTACTGAACCTGGTTTGGACA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41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03g02644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AGGGATATCATTTGACGGAGAC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CTTGTCTACGAAAGCTGATTC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04g04635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GATGAGGAGCTAGGGAAG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CTGGGTGGAATTGGACTC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4480">
                <a:tc rowSpan="2"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GP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08g03204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CCGCAGCCTTGAAACATT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CCAAAACAGCGGAAACTC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6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04g04677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ACGCAATGCTGGAGTACAGTGT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TCTCGAGGTTACGGTTATTGAT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4120">
                <a:tc rowSpan="8"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03g07975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GACAGGATGAAGGCAATCACA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TCCTTGAGGCTCCTAGCATACT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4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03g07974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TAATAGTACCTGATCTTCCTTACC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TATGGAAGTGCATTCTTCAGGCT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41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08g01359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ACGTATCATCGCCGAGAC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CTCACCTCTGCTCCAAGA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4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03g07970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TCAGGAGATCAAGAAGGTTACA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CCGCTCATCTCAAGGCATA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41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03g01684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AGACACTCCGCCCATTTT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AATGATTCCGCTTGGCT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4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02g07733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GCATCCAGAGCAATCACT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ATCAATATGCGCTCCCAC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41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03g07130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TAATTGCTGGGATCGCTG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TCTACAAGTTCCCGGCAC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9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01g06955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AGGTGCTGAACGGTGAA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GCCTAAGTTTGCTCATCC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99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D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08g01403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TGCCGGTGCTGCCCAAT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TCGTCGGCAGGTTGAGCATC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412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WRKY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01g07307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GCACAACCACTCCGCCA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CTCCTCCCATCTCCAGC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44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PR1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s07g01292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ATGCTATGCTACGTGTTTATG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CTAAGCAAATACGGCTGAC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矩形 7"/>
          <p:cNvSpPr/>
          <p:nvPr/>
        </p:nvSpPr>
        <p:spPr>
          <a:xfrm>
            <a:off x="813960" y="4568760"/>
            <a:ext cx="237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 baseline="30000">
                <a:solidFill>
                  <a:srgbClr val="000000"/>
                </a:solidFill>
                <a:latin typeface="Times New Roman"/>
              </a:rPr>
              <a:t>a</a:t>
            </a:r>
            <a:r>
              <a:rPr b="1" lang="en-US" sz="800" spc="-1" strike="noStrike" baseline="30000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GenBank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Accession (</a:t>
            </a:r>
            <a:r>
              <a:rPr b="0" lang="en-US" sz="800" spc="-1" strike="noStrike" u="sng">
                <a:solidFill>
                  <a:srgbClr val="009999"/>
                </a:solidFill>
                <a:uFillTx/>
                <a:latin typeface="Times New Roman"/>
                <a:hlinkClick r:id="rId1"/>
              </a:rPr>
              <a:t>http://www.ncbi.nlm.nih.gov/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4-14T11:25:04Z</dcterms:created>
  <dc:creator>zsd010</dc:creator>
  <dc:description/>
  <dc:language>en-US</dc:language>
  <cp:lastModifiedBy>PC</cp:lastModifiedBy>
  <dcterms:modified xsi:type="dcterms:W3CDTF">2015-05-02T02:41:11Z</dcterms:modified>
  <cp:revision>165</cp:revision>
  <dc:subject/>
  <dc:title>幻灯片 1</dc:title>
</cp:coreProperties>
</file>